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5781"/>
  </p:normalViewPr>
  <p:slideViewPr>
    <p:cSldViewPr snapToGrid="0">
      <p:cViewPr varScale="1">
        <p:scale>
          <a:sx n="111" d="100"/>
          <a:sy n="111" d="100"/>
        </p:scale>
        <p:origin x="63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DFA1CC-4C78-7B10-2214-D9E16F93A4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6B5B588-8B38-3B3C-DE78-2F66BCE4F8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6F2C1A-B25D-B73A-8B40-E1037FBAE7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7356B-8507-1D4B-8077-9AF50A35EFD1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FDB509-CEDC-BDC7-7E5D-05AE033157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638DC1-5810-4CE9-EBF2-2031322BF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C9F7-3D01-064F-90C4-AA6E42429D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63062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FB9010-0331-7EC9-A1B6-7E65B28F78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45C4A38-1434-FC08-C8CF-BD1CCEFC65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3726AA-5F61-E157-673C-375021AF03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7356B-8507-1D4B-8077-9AF50A35EFD1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A1A953-3F8C-E39D-8A56-5CD4F1343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C946B9-EA68-6196-BD88-0AD81E8E3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C9F7-3D01-064F-90C4-AA6E42429D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6604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37F89C1-6DF6-4FE5-571E-EFBE6EED26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979901-25AB-2147-0173-EEEBB0C906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AFA0E4-7E9A-3B5B-E66D-1D831AFF8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7356B-8507-1D4B-8077-9AF50A35EFD1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00914F-5C45-06AE-6191-B0AB9AD36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BA9FD1-B0BB-66B6-D894-0E1E3EDB85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C9F7-3D01-064F-90C4-AA6E42429D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426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5740B7-7B22-84D9-A4AB-7F03D00C9D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448AEE-622C-77F3-A6C7-21A76C7583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AA8EA9-44F5-DA3F-1BE8-8EA5CBFB1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7356B-8507-1D4B-8077-9AF50A35EFD1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3FCD66-A42D-3984-9C0D-AA9CF9B9F6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689339-5E6E-FD46-7469-5E07B97CD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C9F7-3D01-064F-90C4-AA6E42429D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216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733DA4-A548-47CB-EECF-8FA5AB8C25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E17789-00FB-D9B9-D848-B547CE196E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56BE55-0C47-B92B-2A3D-372A27B3BA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7356B-8507-1D4B-8077-9AF50A35EFD1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7B7E8F-D4B7-F9DB-DF2A-64BF0E0AA1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C0CC65-975C-A5FA-B53C-1D5E67ABE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C9F7-3D01-064F-90C4-AA6E42429D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437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50AEF1-9DAA-74C4-E58A-6C4CB17B04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8B4944-FC9C-AF52-2F82-66D8FCFE0E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41E950-B35F-7520-97D9-319B9833EB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043432-E0D2-25AB-273E-933B6FA70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7356B-8507-1D4B-8077-9AF50A35EFD1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6F6709-9D96-B565-A75D-49B5B80F04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E62AFE-C904-72BD-CF72-3855AA878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C9F7-3D01-064F-90C4-AA6E42429D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0862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5DF346-5CD4-29BD-F4F2-F2155D3AB9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2817F7-5FFB-CE2F-A1FA-48629F2B08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924566-97E7-7C30-18E9-FC6B6D5A09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3DE8728-9236-D924-B6C0-250E8EA750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671F4F9-EEBA-78F7-319C-70CDA054D7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74106C2-CD96-AD4F-0029-6B809EAF0C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7356B-8507-1D4B-8077-9AF50A35EFD1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4D8136E-5D92-27E4-023A-D8408106BC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CDE409-F22E-8C27-FE5F-5DEB57E1D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C9F7-3D01-064F-90C4-AA6E42429D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351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CD50E7-18B7-F21F-2001-F3C4C2EEC8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7E6E2A2-5544-6AAA-DC8C-4AD2C10ECD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7356B-8507-1D4B-8077-9AF50A35EFD1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FCA5F35-38E1-1610-BE1B-6CFC25CBC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F7F2704-9625-799A-3A44-2BD1BB45BA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C9F7-3D01-064F-90C4-AA6E42429D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077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B29B8F6-4BBB-5490-DB4D-AED2683C8B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7356B-8507-1D4B-8077-9AF50A35EFD1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8ECCA5F-B516-D2C3-CBDD-4C42FCD22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9AD315F-1436-5450-797D-82D1B41A9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C9F7-3D01-064F-90C4-AA6E42429D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099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EC142A-57F5-5D7C-0797-9D06B9860A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2E07FD-BB41-B025-E0F0-C2D8F7E56D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81098B-E9F0-BC7D-1F33-8888D88C99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12CD18-2467-6D16-B282-A27E538EC6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7356B-8507-1D4B-8077-9AF50A35EFD1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83001C-C107-0056-DF75-FE3C7589C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78694E-BEFF-4DCE-36EE-4BCB0C7B37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C9F7-3D01-064F-90C4-AA6E42429D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169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DA7822-045D-6D25-8911-E3A3236BBB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3560F0C-41F7-D170-5420-238B55B350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013868-C825-D06E-86ED-E1BBF09B8E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2E1ED7-2D72-165F-DCCE-805590A725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7356B-8507-1D4B-8077-9AF50A35EFD1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D81D5E-23C7-2D7B-7339-CE40DCCB02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8CC7B0-D79F-69FF-927E-6C3EFB0F1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C9F7-3D01-064F-90C4-AA6E42429D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5717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E061604-5230-54E6-B9E4-1790314076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985487-549D-1893-0946-DA53A43678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0B8333-FB42-A0B8-A64E-FD12E14C05F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F7356B-8507-1D4B-8077-9AF50A35EFD1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1A600A-4028-2DA4-53C0-F9E4A2E10D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968BDA-853F-4B04-C680-F9B9AB2E14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0BC9F7-3D01-064F-90C4-AA6E42429D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470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1D43DEDF-B082-ACA9-4E98-1F379D9BEE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1500368"/>
              </p:ext>
            </p:extLst>
          </p:nvPr>
        </p:nvGraphicFramePr>
        <p:xfrm>
          <a:off x="1839410" y="243942"/>
          <a:ext cx="5943600" cy="3949700"/>
        </p:xfrm>
        <a:graphic>
          <a:graphicData uri="http://schemas.openxmlformats.org/drawingml/2006/table">
            <a:tbl>
              <a:tblPr/>
              <a:tblGrid>
                <a:gridCol w="1651172">
                  <a:extLst>
                    <a:ext uri="{9D8B030D-6E8A-4147-A177-3AD203B41FA5}">
                      <a16:colId xmlns:a16="http://schemas.microsoft.com/office/drawing/2014/main" val="1053028832"/>
                    </a:ext>
                  </a:extLst>
                </a:gridCol>
                <a:gridCol w="931112">
                  <a:extLst>
                    <a:ext uri="{9D8B030D-6E8A-4147-A177-3AD203B41FA5}">
                      <a16:colId xmlns:a16="http://schemas.microsoft.com/office/drawing/2014/main" val="1998128626"/>
                    </a:ext>
                  </a:extLst>
                </a:gridCol>
                <a:gridCol w="931112">
                  <a:extLst>
                    <a:ext uri="{9D8B030D-6E8A-4147-A177-3AD203B41FA5}">
                      <a16:colId xmlns:a16="http://schemas.microsoft.com/office/drawing/2014/main" val="2059406850"/>
                    </a:ext>
                  </a:extLst>
                </a:gridCol>
                <a:gridCol w="810068">
                  <a:extLst>
                    <a:ext uri="{9D8B030D-6E8A-4147-A177-3AD203B41FA5}">
                      <a16:colId xmlns:a16="http://schemas.microsoft.com/office/drawing/2014/main" val="3667601493"/>
                    </a:ext>
                  </a:extLst>
                </a:gridCol>
                <a:gridCol w="810068">
                  <a:extLst>
                    <a:ext uri="{9D8B030D-6E8A-4147-A177-3AD203B41FA5}">
                      <a16:colId xmlns:a16="http://schemas.microsoft.com/office/drawing/2014/main" val="600958254"/>
                    </a:ext>
                  </a:extLst>
                </a:gridCol>
                <a:gridCol w="810068">
                  <a:extLst>
                    <a:ext uri="{9D8B030D-6E8A-4147-A177-3AD203B41FA5}">
                      <a16:colId xmlns:a16="http://schemas.microsoft.com/office/drawing/2014/main" val="1504566216"/>
                    </a:ext>
                  </a:extLst>
                </a:gridCol>
              </a:tblGrid>
              <a:tr h="317500">
                <a:tc gridSpan="6"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ak Strain vs Systolic Strain Rate Regional Correlation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519779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rain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ion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sal-P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d-P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ical-P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-P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0142016"/>
                  </a:ext>
                </a:extLst>
              </a:tr>
              <a:tr h="279400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umferential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sal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1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4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0719196"/>
                  </a:ext>
                </a:extLst>
              </a:tr>
              <a:tr h="2794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d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4325819"/>
                  </a:ext>
                </a:extLst>
              </a:tr>
              <a:tr h="2794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ical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4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4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5167874"/>
                  </a:ext>
                </a:extLst>
              </a:tr>
              <a:tr h="2794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4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4058039"/>
                  </a:ext>
                </a:extLst>
              </a:tr>
              <a:tr h="279400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dial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sal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7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2045678"/>
                  </a:ext>
                </a:extLst>
              </a:tr>
              <a:tr h="2794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d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2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4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371660"/>
                  </a:ext>
                </a:extLst>
              </a:tr>
              <a:tr h="2794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ical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1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6953180"/>
                  </a:ext>
                </a:extLst>
              </a:tr>
              <a:tr h="2794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1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8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0989359"/>
                  </a:ext>
                </a:extLst>
              </a:tr>
              <a:tr h="279400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face Area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sal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8326762"/>
                  </a:ext>
                </a:extLst>
              </a:tr>
              <a:tr h="2794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d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5565139"/>
                  </a:ext>
                </a:extLst>
              </a:tr>
              <a:tr h="2794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ical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9638556"/>
                  </a:ext>
                </a:extLst>
              </a:tr>
              <a:tr h="2794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1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5599018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8A2F3482-055A-3BAC-D573-D9044B7A07C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1874950"/>
              </p:ext>
            </p:extLst>
          </p:nvPr>
        </p:nvGraphicFramePr>
        <p:xfrm>
          <a:off x="1839410" y="4193642"/>
          <a:ext cx="8420097" cy="2476500"/>
        </p:xfrm>
        <a:graphic>
          <a:graphicData uri="http://schemas.openxmlformats.org/drawingml/2006/table">
            <a:tbl>
              <a:tblPr/>
              <a:tblGrid>
                <a:gridCol w="1660301">
                  <a:extLst>
                    <a:ext uri="{9D8B030D-6E8A-4147-A177-3AD203B41FA5}">
                      <a16:colId xmlns:a16="http://schemas.microsoft.com/office/drawing/2014/main" val="806473887"/>
                    </a:ext>
                  </a:extLst>
                </a:gridCol>
                <a:gridCol w="936260">
                  <a:extLst>
                    <a:ext uri="{9D8B030D-6E8A-4147-A177-3AD203B41FA5}">
                      <a16:colId xmlns:a16="http://schemas.microsoft.com/office/drawing/2014/main" val="2056801718"/>
                    </a:ext>
                  </a:extLst>
                </a:gridCol>
                <a:gridCol w="936260">
                  <a:extLst>
                    <a:ext uri="{9D8B030D-6E8A-4147-A177-3AD203B41FA5}">
                      <a16:colId xmlns:a16="http://schemas.microsoft.com/office/drawing/2014/main" val="4238797531"/>
                    </a:ext>
                  </a:extLst>
                </a:gridCol>
                <a:gridCol w="814546">
                  <a:extLst>
                    <a:ext uri="{9D8B030D-6E8A-4147-A177-3AD203B41FA5}">
                      <a16:colId xmlns:a16="http://schemas.microsoft.com/office/drawing/2014/main" val="3366467409"/>
                    </a:ext>
                  </a:extLst>
                </a:gridCol>
                <a:gridCol w="814546">
                  <a:extLst>
                    <a:ext uri="{9D8B030D-6E8A-4147-A177-3AD203B41FA5}">
                      <a16:colId xmlns:a16="http://schemas.microsoft.com/office/drawing/2014/main" val="3451235755"/>
                    </a:ext>
                  </a:extLst>
                </a:gridCol>
                <a:gridCol w="814546">
                  <a:extLst>
                    <a:ext uri="{9D8B030D-6E8A-4147-A177-3AD203B41FA5}">
                      <a16:colId xmlns:a16="http://schemas.microsoft.com/office/drawing/2014/main" val="495280579"/>
                    </a:ext>
                  </a:extLst>
                </a:gridCol>
                <a:gridCol w="814546">
                  <a:extLst>
                    <a:ext uri="{9D8B030D-6E8A-4147-A177-3AD203B41FA5}">
                      <a16:colId xmlns:a16="http://schemas.microsoft.com/office/drawing/2014/main" val="3286684866"/>
                    </a:ext>
                  </a:extLst>
                </a:gridCol>
                <a:gridCol w="814546">
                  <a:extLst>
                    <a:ext uri="{9D8B030D-6E8A-4147-A177-3AD203B41FA5}">
                      <a16:colId xmlns:a16="http://schemas.microsoft.com/office/drawing/2014/main" val="3175434578"/>
                    </a:ext>
                  </a:extLst>
                </a:gridCol>
                <a:gridCol w="814546">
                  <a:extLst>
                    <a:ext uri="{9D8B030D-6E8A-4147-A177-3AD203B41FA5}">
                      <a16:colId xmlns:a16="http://schemas.microsoft.com/office/drawing/2014/main" val="1254877019"/>
                    </a:ext>
                  </a:extLst>
                </a:gridCol>
              </a:tblGrid>
              <a:tr h="254000">
                <a:tc gridSpan="9"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ak Strain vs Systolic Strain Rate Regional Correl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56419420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rain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ion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W-P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-P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-P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S-P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P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W-P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-P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8352907"/>
                  </a:ext>
                </a:extLst>
              </a:tr>
              <a:tr h="279400">
                <a:tc rowSpan="7"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itudin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W-S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1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8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4393362"/>
                  </a:ext>
                </a:extLst>
              </a:tr>
              <a:tr h="2794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4954844"/>
                  </a:ext>
                </a:extLst>
              </a:tr>
              <a:tr h="2794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4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3028337"/>
                  </a:ext>
                </a:extLst>
              </a:tr>
              <a:tr h="2794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S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2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3760576"/>
                  </a:ext>
                </a:extLst>
              </a:tr>
              <a:tr h="2794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2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3205341"/>
                  </a:ext>
                </a:extLst>
              </a:tr>
              <a:tr h="2794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W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2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8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2907968"/>
                  </a:ext>
                </a:extLst>
              </a:tr>
              <a:tr h="2794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-S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2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96932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3449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52</Words>
  <Application>Microsoft Macintosh PowerPoint</Application>
  <PresentationFormat>Widescreen</PresentationFormat>
  <Paragraphs>1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ner Earl</dc:creator>
  <cp:lastModifiedBy>Conner Earl</cp:lastModifiedBy>
  <cp:revision>2</cp:revision>
  <dcterms:created xsi:type="dcterms:W3CDTF">2022-11-01T02:46:41Z</dcterms:created>
  <dcterms:modified xsi:type="dcterms:W3CDTF">2022-11-01T03:05:18Z</dcterms:modified>
</cp:coreProperties>
</file>